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0825C-DB6C-4BC1-B265-F0E1698267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86B16-F9A4-4B90-A279-1A2A9658B6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16014-0B7F-45FF-A4E2-83D3A4D233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02244-752D-4056-A017-B9954792F1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4306C-41DF-4001-A225-975769EB39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3542C-8182-4C2F-A6FA-23D2E4E58E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673E4-CB34-44EC-A3B5-61C5FDA9EE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CE4BF-B5A9-4A38-A6D4-4DC9CB6223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C82AE-775D-49BB-B630-6F94569B6B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F57D4-7AAD-45CA-887A-4BB1220A89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12BA7-16B3-4FD4-BAEF-3749859594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B1CC7D-DE70-4F29-A0BB-6DE456BD10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CB344D-A1FF-4F6B-B8C0-1B7B0C04EB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6"/>
          <p:cNvSpPr/>
          <p:nvPr/>
        </p:nvSpPr>
        <p:spPr>
          <a:xfrm>
            <a:off x="708120" y="609480"/>
            <a:ext cx="1669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7"/>
          <p:cNvGrpSpPr/>
          <p:nvPr/>
        </p:nvGrpSpPr>
        <p:grpSpPr>
          <a:xfrm>
            <a:off x="3218040" y="1996920"/>
            <a:ext cx="2784960" cy="1601640"/>
            <a:chOff x="3218040" y="1996920"/>
            <a:chExt cx="2784960" cy="1601640"/>
          </a:xfrm>
        </p:grpSpPr>
        <p:sp>
          <p:nvSpPr>
            <p:cNvPr id="43" name="Text Box 64"/>
            <p:cNvSpPr/>
            <p:nvPr/>
          </p:nvSpPr>
          <p:spPr>
            <a:xfrm rot="16200000">
              <a:off x="2891520" y="2514960"/>
              <a:ext cx="92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old chan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67"/>
            <p:cNvSpPr/>
            <p:nvPr/>
          </p:nvSpPr>
          <p:spPr>
            <a:xfrm flipV="1">
              <a:off x="3770280" y="3332880"/>
              <a:ext cx="4284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68"/>
            <p:cNvSpPr/>
            <p:nvPr/>
          </p:nvSpPr>
          <p:spPr>
            <a:xfrm flipV="1">
              <a:off x="3770280" y="3067920"/>
              <a:ext cx="4284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69"/>
            <p:cNvSpPr/>
            <p:nvPr/>
          </p:nvSpPr>
          <p:spPr>
            <a:xfrm flipV="1">
              <a:off x="3770280" y="2538000"/>
              <a:ext cx="4284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71"/>
            <p:cNvSpPr/>
            <p:nvPr/>
          </p:nvSpPr>
          <p:spPr>
            <a:xfrm>
              <a:off x="3640320" y="32479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73"/>
            <p:cNvSpPr/>
            <p:nvPr/>
          </p:nvSpPr>
          <p:spPr>
            <a:xfrm>
              <a:off x="3641040" y="218808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78"/>
            <p:cNvSpPr/>
            <p:nvPr/>
          </p:nvSpPr>
          <p:spPr>
            <a:xfrm>
              <a:off x="4228200" y="3219480"/>
              <a:ext cx="225000" cy="1087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79"/>
            <p:cNvSpPr/>
            <p:nvPr/>
          </p:nvSpPr>
          <p:spPr>
            <a:xfrm>
              <a:off x="3987720" y="3222000"/>
              <a:ext cx="225000" cy="1087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75"/>
            <p:cNvSpPr/>
            <p:nvPr/>
          </p:nvSpPr>
          <p:spPr>
            <a:xfrm>
              <a:off x="4940280" y="2557800"/>
              <a:ext cx="239040" cy="773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81"/>
            <p:cNvSpPr/>
            <p:nvPr/>
          </p:nvSpPr>
          <p:spPr>
            <a:xfrm flipV="1">
              <a:off x="5054040" y="2377440"/>
              <a:ext cx="0" cy="18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82"/>
            <p:cNvSpPr/>
            <p:nvPr/>
          </p:nvSpPr>
          <p:spPr>
            <a:xfrm>
              <a:off x="5004720" y="2377440"/>
              <a:ext cx="11520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76"/>
            <p:cNvSpPr/>
            <p:nvPr/>
          </p:nvSpPr>
          <p:spPr>
            <a:xfrm>
              <a:off x="4685400" y="2670120"/>
              <a:ext cx="239040" cy="660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" name="Group 181"/>
            <p:cNvGrpSpPr/>
            <p:nvPr/>
          </p:nvGrpSpPr>
          <p:grpSpPr>
            <a:xfrm>
              <a:off x="4747320" y="2500920"/>
              <a:ext cx="115200" cy="164160"/>
              <a:chOff x="4747320" y="2500920"/>
              <a:chExt cx="115200" cy="164160"/>
            </a:xfrm>
          </p:grpSpPr>
          <p:sp>
            <p:nvSpPr>
              <p:cNvPr id="56" name="Line 83"/>
              <p:cNvSpPr/>
              <p:nvPr/>
            </p:nvSpPr>
            <p:spPr>
              <a:xfrm flipV="1">
                <a:off x="4796640" y="2500920"/>
                <a:ext cx="3960" cy="164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84"/>
              <p:cNvSpPr/>
              <p:nvPr/>
            </p:nvSpPr>
            <p:spPr>
              <a:xfrm>
                <a:off x="4747320" y="2500920"/>
                <a:ext cx="115200" cy="4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480" bIns="-4248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Group 180"/>
            <p:cNvGrpSpPr/>
            <p:nvPr/>
          </p:nvGrpSpPr>
          <p:grpSpPr>
            <a:xfrm>
              <a:off x="4290480" y="3180600"/>
              <a:ext cx="112320" cy="63000"/>
              <a:chOff x="4290480" y="3180600"/>
              <a:chExt cx="112320" cy="63000"/>
            </a:xfrm>
          </p:grpSpPr>
          <p:sp>
            <p:nvSpPr>
              <p:cNvPr id="59" name="Line 87"/>
              <p:cNvSpPr/>
              <p:nvPr/>
            </p:nvSpPr>
            <p:spPr>
              <a:xfrm flipV="1">
                <a:off x="4340520" y="3180600"/>
                <a:ext cx="0" cy="63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88"/>
              <p:cNvSpPr/>
              <p:nvPr/>
            </p:nvSpPr>
            <p:spPr>
              <a:xfrm>
                <a:off x="4290480" y="3180960"/>
                <a:ext cx="1123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1" name="Group 182" descr=""/>
            <p:cNvPicPr/>
            <p:nvPr/>
          </p:nvPicPr>
          <p:blipFill>
            <a:blip r:embed="rId1"/>
            <a:stretch/>
          </p:blipFill>
          <p:spPr>
            <a:xfrm>
              <a:off x="4047840" y="3182040"/>
              <a:ext cx="121680" cy="4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Line 93"/>
            <p:cNvSpPr/>
            <p:nvPr/>
          </p:nvSpPr>
          <p:spPr>
            <a:xfrm>
              <a:off x="3810240" y="2008800"/>
              <a:ext cx="2880" cy="1324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95"/>
            <p:cNvSpPr/>
            <p:nvPr/>
          </p:nvSpPr>
          <p:spPr>
            <a:xfrm>
              <a:off x="4317120" y="2196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65"/>
            <p:cNvSpPr/>
            <p:nvPr/>
          </p:nvSpPr>
          <p:spPr>
            <a:xfrm>
              <a:off x="3810600" y="3331800"/>
              <a:ext cx="150336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04"/>
            <p:cNvSpPr/>
            <p:nvPr/>
          </p:nvSpPr>
          <p:spPr>
            <a:xfrm>
              <a:off x="4121640" y="341568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106"/>
            <p:cNvSpPr/>
            <p:nvPr/>
          </p:nvSpPr>
          <p:spPr>
            <a:xfrm>
              <a:off x="4856040" y="3415680"/>
              <a:ext cx="15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7" name="Group 4"/>
            <p:cNvGrpSpPr/>
            <p:nvPr/>
          </p:nvGrpSpPr>
          <p:grpSpPr>
            <a:xfrm>
              <a:off x="5382720" y="2272320"/>
              <a:ext cx="620280" cy="488160"/>
              <a:chOff x="5382720" y="2272320"/>
              <a:chExt cx="620280" cy="488160"/>
            </a:xfrm>
          </p:grpSpPr>
          <p:sp>
            <p:nvSpPr>
              <p:cNvPr id="68" name="Rectangle 103"/>
              <p:cNvSpPr/>
              <p:nvPr/>
            </p:nvSpPr>
            <p:spPr>
              <a:xfrm>
                <a:off x="5382720" y="2292840"/>
                <a:ext cx="144360" cy="1443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104"/>
              <p:cNvSpPr/>
              <p:nvPr/>
            </p:nvSpPr>
            <p:spPr>
              <a:xfrm>
                <a:off x="5604480" y="2272320"/>
                <a:ext cx="398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EG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105"/>
              <p:cNvSpPr/>
              <p:nvPr/>
            </p:nvSpPr>
            <p:spPr>
              <a:xfrm>
                <a:off x="5382720" y="2597760"/>
                <a:ext cx="144360" cy="14436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104"/>
              <p:cNvSpPr/>
              <p:nvPr/>
            </p:nvSpPr>
            <p:spPr>
              <a:xfrm>
                <a:off x="5611320" y="2577600"/>
                <a:ext cx="357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FG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Line 69"/>
            <p:cNvSpPr/>
            <p:nvPr/>
          </p:nvSpPr>
          <p:spPr>
            <a:xfrm flipV="1">
              <a:off x="3770280" y="2802960"/>
              <a:ext cx="4284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69"/>
            <p:cNvSpPr/>
            <p:nvPr/>
          </p:nvSpPr>
          <p:spPr>
            <a:xfrm flipV="1">
              <a:off x="3770280" y="2273040"/>
              <a:ext cx="42840" cy="2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641040" y="271800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" name="Group 6"/>
            <p:cNvGrpSpPr/>
            <p:nvPr/>
          </p:nvGrpSpPr>
          <p:grpSpPr>
            <a:xfrm>
              <a:off x="4103280" y="2384280"/>
              <a:ext cx="699480" cy="89280"/>
              <a:chOff x="4103280" y="2384280"/>
              <a:chExt cx="699480" cy="89280"/>
            </a:xfrm>
          </p:grpSpPr>
          <p:sp>
            <p:nvSpPr>
              <p:cNvPr id="76" name="Line 165"/>
              <p:cNvSpPr/>
              <p:nvPr/>
            </p:nvSpPr>
            <p:spPr>
              <a:xfrm>
                <a:off x="4103280" y="2388600"/>
                <a:ext cx="699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81"/>
              <p:cNvSpPr/>
              <p:nvPr/>
            </p:nvSpPr>
            <p:spPr>
              <a:xfrm flipV="1">
                <a:off x="4107960" y="2388600"/>
                <a:ext cx="0" cy="84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81"/>
              <p:cNvSpPr/>
              <p:nvPr/>
            </p:nvSpPr>
            <p:spPr>
              <a:xfrm flipV="1">
                <a:off x="4798440" y="2384280"/>
                <a:ext cx="0" cy="84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" name="Group 116"/>
            <p:cNvGrpSpPr/>
            <p:nvPr/>
          </p:nvGrpSpPr>
          <p:grpSpPr>
            <a:xfrm>
              <a:off x="4339440" y="2196000"/>
              <a:ext cx="720360" cy="89280"/>
              <a:chOff x="4339440" y="2196000"/>
              <a:chExt cx="720360" cy="89280"/>
            </a:xfrm>
          </p:grpSpPr>
          <p:sp>
            <p:nvSpPr>
              <p:cNvPr id="80" name="Line 165"/>
              <p:cNvSpPr/>
              <p:nvPr/>
            </p:nvSpPr>
            <p:spPr>
              <a:xfrm>
                <a:off x="4339440" y="2200320"/>
                <a:ext cx="720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81"/>
              <p:cNvSpPr/>
              <p:nvPr/>
            </p:nvSpPr>
            <p:spPr>
              <a:xfrm flipV="1">
                <a:off x="4344480" y="2200320"/>
                <a:ext cx="0" cy="84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81"/>
              <p:cNvSpPr/>
              <p:nvPr/>
            </p:nvSpPr>
            <p:spPr>
              <a:xfrm flipV="1">
                <a:off x="5055480" y="2196000"/>
                <a:ext cx="0" cy="84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160" bIns="38160" anchor="t">
                <a:noAutofit/>
              </a:bodyPr>
              <a:p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" name="Text Box 95"/>
            <p:cNvSpPr/>
            <p:nvPr/>
          </p:nvSpPr>
          <p:spPr>
            <a:xfrm>
              <a:off x="4564800" y="19969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04"/>
            <p:cNvSpPr/>
            <p:nvPr/>
          </p:nvSpPr>
          <p:spPr>
            <a:xfrm>
              <a:off x="3331440" y="3415680"/>
              <a:ext cx="541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lucose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04"/>
            <p:cNvSpPr/>
            <p:nvPr/>
          </p:nvSpPr>
          <p:spPr>
            <a:xfrm>
              <a:off x="5193000" y="3415680"/>
              <a:ext cx="543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mmol/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Box 8"/>
          <p:cNvSpPr/>
          <p:nvPr/>
        </p:nvSpPr>
        <p:spPr>
          <a:xfrm>
            <a:off x="1600200" y="4511520"/>
            <a:ext cx="58672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MEC-1 cells were cultured with glucose at the doses of 5.5 mmol/l and 15 mmol/l for 6 h. The mRNA for VEGF and bFGF was detected by quantitative RT-PCR and normalized to GAPDH. * indicates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0.05 compared to 5.5 mmol/l glucos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3T03:02:17Z</dcterms:created>
  <dc:creator>Cynthia</dc:creator>
  <dc:description/>
  <dc:language>en-US</dc:language>
  <cp:lastModifiedBy>0010850</cp:lastModifiedBy>
  <dcterms:modified xsi:type="dcterms:W3CDTF">2015-10-08T10:02:48Z</dcterms:modified>
  <cp:revision>31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